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320" r:id="rId3"/>
    <p:sldId id="273" r:id="rId4"/>
    <p:sldId id="272" r:id="rId5"/>
    <p:sldId id="274" r:id="rId6"/>
    <p:sldId id="318" r:id="rId7"/>
    <p:sldId id="317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5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0B55F-5CB3-E180-CA1E-F0ACA3D646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656B19-3FEE-8936-9AEF-9D917C7397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A7163F-C126-8461-B816-C2C6FDDDC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94330F-826F-2806-ECC7-820140963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D5DBE9-CB70-E9B6-CD6B-729572439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541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9E988-E18B-1623-2F7D-27E31F2992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06769D-0687-FC7F-C55C-F6E2E48AD2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25E45A-10C7-8904-042D-65DDD6889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07E7A4-94A8-F45E-C3FC-F45AEFFD7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9655AB-9A8E-D915-4D4F-FF4838AB9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779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D633EC-43D7-FDE4-D983-A863AF2E80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6E42DA-6FB1-1F19-23C7-5101DF386D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21F76A-684C-0771-F498-8C9B4F1B1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BFE641-60CD-32F8-763D-60F64C89D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FF8092-782E-7162-A722-ECBB9ED3C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3015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C84614-C147-6EAD-4A71-564D4A99EF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8267AC-B5AA-952A-BC39-20B0BA8AAA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A0A244-13A0-E99E-A2A7-C69E418BC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00E0DA-DA81-C0B0-24C6-3D6AD2EE7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A52A50-0347-B8CB-FED9-5A3261555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419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687A26-E7EA-5802-B294-5BCC415BFC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2697CF-BA49-37A7-F196-B6C7ED04FA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DBDB2D-B402-9496-3361-FF4650C37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290948-0ED6-7B20-B2BD-2F0A591A2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6BCF5-6EE8-0672-507D-0028EABC4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082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7B69CD-CC11-6923-120D-0A0E55B286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BD07DF-B6AA-6897-990E-7806D3B10F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B28E78-DD35-5E77-5818-1CD044250D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A66BD8-BA0F-0C4D-BA7B-DEC6A29BB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D38A05-A08F-6737-18B4-5F6746E74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EE5F4F-A312-ABC9-F4C5-35556CE81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675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DF881D-154D-6C44-F19C-503445F424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279A19-C4EC-6A64-B76E-170510AF0E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43C591-774E-EF51-3878-48A5F99E72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70AAE7-4DAD-D673-A157-3B37061F63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A222EC-E252-5959-448D-31BF5A69BD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CB55A5-DA8D-2769-18DF-BDC0860DA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EEA18BF-4865-A426-E462-BF0724F37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2A436A8-01C4-54DF-B876-D9809F715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799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58EAED-66F5-CF86-DF97-4C860C13B8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0BA0A8-5FC0-7AA2-0F59-0E2185E47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287064-F84A-E8FE-1868-0860EF6C0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2E65645-5247-A9CA-9261-13729419B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636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F8B0BBD-D096-4293-351E-6449CC29E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FDBDF9D-0BDB-9023-45A5-24BA88C9B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A58519-4FA0-7AED-39D6-C97F9E3CC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88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0E88E-36A8-C1EC-2692-563FE5C6FC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2FF99D-1FD9-ABCD-F69A-72E46F48F2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2A9250-C92D-00C3-2F21-100406135E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724BD1-F6A8-17CE-53ED-68DB28B20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CB09B2-BD24-5D76-FEDD-1D6758D99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6B539B-913A-7865-78BE-982FEB31E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692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BD7BBF-E4BD-114C-B1C8-09E817FC0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41C3490-BF8B-01B6-5103-C26155F5C3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85880A-A3AD-A4A4-9ABF-13B4F68C5E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3ED2B8-79FF-8DA3-D828-471E92509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73C8E3-638D-15C0-9253-9D47E6033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FDC5D3-EC6C-07CE-028D-8852C9604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921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80FDD1-72A6-976E-EA1A-F132EE6E70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66C0AE-68B3-23D0-91BD-D29B644D84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8D44D8-AB03-A0E9-0A0D-88D8FD653D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C6C3B7-E71B-4BEC-B61F-B95868AABAE6}" type="datetimeFigureOut">
              <a:rPr lang="en-US" smtClean="0"/>
              <a:t>6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BDC2FD-65A9-26BF-30C5-CAD8B67C8B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DDBFC1-CBA6-6BDE-B9D5-5870EC4188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A99D2-3B0A-40CB-BE69-F7C299E7D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152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hyperlink" Target="mailto:bgomperts@mednet.ucla.edu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1.png"/><Relationship Id="rId3" Type="http://schemas.microsoft.com/office/2007/relationships/hdphoto" Target="../media/hdphoto3.wdp"/><Relationship Id="rId7" Type="http://schemas.microsoft.com/office/2007/relationships/hdphoto" Target="../media/hdphoto5.wdp"/><Relationship Id="rId12" Type="http://schemas.openxmlformats.org/officeDocument/2006/relationships/image" Target="../media/image10.png"/><Relationship Id="rId2" Type="http://schemas.openxmlformats.org/officeDocument/2006/relationships/image" Target="../media/image5.png"/><Relationship Id="rId16" Type="http://schemas.microsoft.com/office/2007/relationships/hdphoto" Target="../media/hdphoto9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microsoft.com/office/2007/relationships/hdphoto" Target="../media/hdphoto7.wdp"/><Relationship Id="rId5" Type="http://schemas.microsoft.com/office/2007/relationships/hdphoto" Target="../media/hdphoto4.wdp"/><Relationship Id="rId15" Type="http://schemas.openxmlformats.org/officeDocument/2006/relationships/image" Target="../media/image12.png"/><Relationship Id="rId10" Type="http://schemas.openxmlformats.org/officeDocument/2006/relationships/image" Target="../media/image9.png"/><Relationship Id="rId4" Type="http://schemas.openxmlformats.org/officeDocument/2006/relationships/image" Target="../media/image6.png"/><Relationship Id="rId9" Type="http://schemas.microsoft.com/office/2007/relationships/hdphoto" Target="../media/hdphoto6.wdp"/><Relationship Id="rId14" Type="http://schemas.microsoft.com/office/2007/relationships/hdphoto" Target="../media/hdphoto8.wdp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058459-12CB-0329-1904-37FBD249AC27}"/>
              </a:ext>
            </a:extLst>
          </p:cNvPr>
          <p:cNvSpPr txBox="1"/>
          <p:nvPr/>
        </p:nvSpPr>
        <p:spPr>
          <a:xfrm>
            <a:off x="254000" y="1106438"/>
            <a:ext cx="11938000" cy="35086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spcBef>
                <a:spcPts val="1200"/>
              </a:spcBef>
              <a:spcAft>
                <a:spcPts val="600"/>
              </a:spcAft>
            </a:pPr>
            <a:r>
              <a:rPr lang="en-US" sz="24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Material</a:t>
            </a:r>
          </a:p>
          <a:p>
            <a:pPr marL="0" marR="0" algn="ctr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Development of a small cell lung cancer organoid to study cellular interactions and survival after chemotherapy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ctr">
              <a:spcBef>
                <a:spcPts val="1200"/>
              </a:spcBef>
              <a:spcAft>
                <a:spcPts val="12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andani Sen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Caroline Koloff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Souvik Kundu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5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Dan C Wilkinson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Juliette Yang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David W Shia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Luisa K Meneses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Tammy M Rickabaugh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Brigitte N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omperts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</a:t>
            </a:r>
          </a:p>
          <a:p>
            <a:pPr>
              <a:spcBef>
                <a:spcPts val="1200"/>
              </a:spcBef>
              <a:spcAft>
                <a:spcPts val="1200"/>
              </a:spcAft>
            </a:pPr>
            <a:endParaRPr lang="en-US" sz="18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Bef>
                <a:spcPts val="1200"/>
              </a:spcBef>
              <a:spcAft>
                <a:spcPts val="12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ence: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rigitte N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omperts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800" u="sng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hlinkClick r:id="rId2"/>
              </a:rPr>
              <a:t>bgomperts@mednet.ucla.edu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spcBef>
                <a:spcPts val="1200"/>
              </a:spcBef>
              <a:spcAft>
                <a:spcPts val="120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2C96B71-0070-9E98-4C24-F8001BE8BD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602" y="183147"/>
            <a:ext cx="2316798" cy="83221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7547541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AC0B2-60BE-8E0E-EF61-A22817A6DB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s legends</a:t>
            </a:r>
            <a:br>
              <a:rPr lang="en-US" sz="2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endParaRPr lang="en-US" sz="24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215A28-E25D-B6A9-BC9A-451F1236D3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510665"/>
            <a:ext cx="10515600" cy="4351338"/>
          </a:xfrm>
        </p:spPr>
        <p:txBody>
          <a:bodyPr>
            <a:normAutofit fontScale="92500" lnSpcReduction="20000"/>
          </a:bodyPr>
          <a:lstStyle/>
          <a:p>
            <a:pPr marL="0" marR="0" algn="just">
              <a:lnSpc>
                <a:spcPct val="20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1. Effect of different seeding densities of ALF and SCLC on the model phenotype. The selected seeding density for further experiments was a)</a:t>
            </a:r>
            <a:r>
              <a:rPr lang="en-US" sz="1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LF: SCLC-4:1, because b) ALF: SCLC 1:1 and c) 1:4 shows overpopulation of SCLCs after 24h. </a:t>
            </a:r>
          </a:p>
          <a:p>
            <a:pPr marL="0" marR="0" algn="just">
              <a:lnSpc>
                <a:spcPct val="20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2. Phenotypic representation of tumor growth in the SCLC co-cultured model using different SCLC cell lines: a) H1963 and b) H82; (scale bar: 500 µm).</a:t>
            </a:r>
          </a:p>
          <a:p>
            <a:pPr marL="0" marR="0" algn="just">
              <a:lnSpc>
                <a:spcPct val="20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3: IC50 curve of different SCLC cell lines in the model.</a:t>
            </a:r>
          </a:p>
          <a:p>
            <a:pPr marL="0" marR="0" algn="just">
              <a:lnSpc>
                <a:spcPct val="20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4: Automated image intensity analysis in the model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5405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B69F225-4362-1B61-AB58-22BA111CEA28}"/>
              </a:ext>
            </a:extLst>
          </p:cNvPr>
          <p:cNvSpPr txBox="1"/>
          <p:nvPr/>
        </p:nvSpPr>
        <p:spPr>
          <a:xfrm>
            <a:off x="1023811" y="518762"/>
            <a:ext cx="834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76C8E165-3B42-5A3B-DC65-410059F2FA7E}"/>
              </a:ext>
            </a:extLst>
          </p:cNvPr>
          <p:cNvGrpSpPr/>
          <p:nvPr/>
        </p:nvGrpSpPr>
        <p:grpSpPr>
          <a:xfrm>
            <a:off x="1666240" y="1491972"/>
            <a:ext cx="8217217" cy="2840947"/>
            <a:chOff x="1666240" y="1491972"/>
            <a:chExt cx="8217217" cy="2840947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F2686436-05D7-DF40-70AA-E9D94CCB112D}"/>
                </a:ext>
              </a:extLst>
            </p:cNvPr>
            <p:cNvGrpSpPr/>
            <p:nvPr/>
          </p:nvGrpSpPr>
          <p:grpSpPr>
            <a:xfrm>
              <a:off x="1666240" y="1501653"/>
              <a:ext cx="8217217" cy="2831266"/>
              <a:chOff x="67035" y="3717554"/>
              <a:chExt cx="8217217" cy="2831266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C1538F65-D328-6ACE-87DF-0CCC34F38700}"/>
                  </a:ext>
                </a:extLst>
              </p:cNvPr>
              <p:cNvGrpSpPr/>
              <p:nvPr/>
            </p:nvGrpSpPr>
            <p:grpSpPr>
              <a:xfrm>
                <a:off x="67035" y="3720613"/>
                <a:ext cx="3043212" cy="2476754"/>
                <a:chOff x="5452290" y="1077394"/>
                <a:chExt cx="2592246" cy="1865908"/>
              </a:xfrm>
            </p:grpSpPr>
            <p:grpSp>
              <p:nvGrpSpPr>
                <p:cNvPr id="22" name="Group 21">
                  <a:extLst>
                    <a:ext uri="{FF2B5EF4-FFF2-40B4-BE49-F238E27FC236}">
                      <a16:creationId xmlns:a16="http://schemas.microsoft.com/office/drawing/2014/main" id="{4C3F61AF-7DD2-02F0-E42C-8380C92784E6}"/>
                    </a:ext>
                  </a:extLst>
                </p:cNvPr>
                <p:cNvGrpSpPr/>
                <p:nvPr/>
              </p:nvGrpSpPr>
              <p:grpSpPr>
                <a:xfrm>
                  <a:off x="5452290" y="1077394"/>
                  <a:ext cx="2592246" cy="1865908"/>
                  <a:chOff x="3200009" y="3231428"/>
                  <a:chExt cx="2539284" cy="2057220"/>
                </a:xfrm>
              </p:grpSpPr>
              <p:pic>
                <p:nvPicPr>
                  <p:cNvPr id="24" name="Picture 23">
                    <a:extLst>
                      <a:ext uri="{FF2B5EF4-FFF2-40B4-BE49-F238E27FC236}">
                        <a16:creationId xmlns:a16="http://schemas.microsoft.com/office/drawing/2014/main" id="{97A2D659-2DF1-4F7C-8E82-72FDAE7F739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20103" r="29508" b="11024"/>
                  <a:stretch/>
                </p:blipFill>
                <p:spPr>
                  <a:xfrm>
                    <a:off x="3200009" y="3231428"/>
                    <a:ext cx="2105569" cy="2057220"/>
                  </a:xfrm>
                  <a:prstGeom prst="rect">
                    <a:avLst/>
                  </a:prstGeom>
                </p:spPr>
              </p:pic>
              <p:sp>
                <p:nvSpPr>
                  <p:cNvPr id="25" name="TextBox 24">
                    <a:extLst>
                      <a:ext uri="{FF2B5EF4-FFF2-40B4-BE49-F238E27FC236}">
                        <a16:creationId xmlns:a16="http://schemas.microsoft.com/office/drawing/2014/main" id="{EEEC5B26-F010-8A23-9FB9-CFA3827C602C}"/>
                      </a:ext>
                    </a:extLst>
                  </p:cNvPr>
                  <p:cNvSpPr txBox="1"/>
                  <p:nvPr/>
                </p:nvSpPr>
                <p:spPr>
                  <a:xfrm>
                    <a:off x="4452326" y="3249583"/>
                    <a:ext cx="1286967" cy="2492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20" b="1" dirty="0">
                        <a:solidFill>
                          <a:srgbClr val="FF0000"/>
                        </a:solidFill>
                      </a:rPr>
                      <a:t>Fibroblast </a:t>
                    </a:r>
                    <a:r>
                      <a:rPr lang="en-US" sz="1020" b="1" dirty="0">
                        <a:solidFill>
                          <a:srgbClr val="92D050"/>
                        </a:solidFill>
                      </a:rPr>
                      <a:t>SCLC</a:t>
                    </a:r>
                  </a:p>
                </p:txBody>
              </p:sp>
            </p:grpSp>
            <p:cxnSp>
              <p:nvCxnSpPr>
                <p:cNvPr id="23" name="Straight Connector 22">
                  <a:extLst>
                    <a:ext uri="{FF2B5EF4-FFF2-40B4-BE49-F238E27FC236}">
                      <a16:creationId xmlns:a16="http://schemas.microsoft.com/office/drawing/2014/main" id="{5F7CB0C4-037B-D9E6-AC5D-F54797DC8A5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077540" y="2850544"/>
                  <a:ext cx="470136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AD5C7040-1A0F-DB85-CD70-024DC7C3E0A5}"/>
                  </a:ext>
                </a:extLst>
              </p:cNvPr>
              <p:cNvGrpSpPr/>
              <p:nvPr/>
            </p:nvGrpSpPr>
            <p:grpSpPr>
              <a:xfrm>
                <a:off x="2700793" y="3723225"/>
                <a:ext cx="2729740" cy="2825595"/>
                <a:chOff x="7835035" y="1084045"/>
                <a:chExt cx="2476504" cy="2116704"/>
              </a:xfrm>
            </p:grpSpPr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BD8BD262-027D-9035-3820-6E7F1BF3A612}"/>
                    </a:ext>
                  </a:extLst>
                </p:cNvPr>
                <p:cNvSpPr txBox="1"/>
                <p:nvPr/>
              </p:nvSpPr>
              <p:spPr>
                <a:xfrm>
                  <a:off x="7875408" y="2970188"/>
                  <a:ext cx="2225299" cy="2305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7" name="Group 16">
                  <a:extLst>
                    <a:ext uri="{FF2B5EF4-FFF2-40B4-BE49-F238E27FC236}">
                      <a16:creationId xmlns:a16="http://schemas.microsoft.com/office/drawing/2014/main" id="{3149C94D-B891-E8B1-AD4F-3E8953D43693}"/>
                    </a:ext>
                  </a:extLst>
                </p:cNvPr>
                <p:cNvGrpSpPr/>
                <p:nvPr/>
              </p:nvGrpSpPr>
              <p:grpSpPr>
                <a:xfrm>
                  <a:off x="7835035" y="1084045"/>
                  <a:ext cx="2476504" cy="1861882"/>
                  <a:chOff x="7825978" y="1024558"/>
                  <a:chExt cx="2476504" cy="1861882"/>
                </a:xfrm>
              </p:grpSpPr>
              <p:grpSp>
                <p:nvGrpSpPr>
                  <p:cNvPr id="18" name="Group 17">
                    <a:extLst>
                      <a:ext uri="{FF2B5EF4-FFF2-40B4-BE49-F238E27FC236}">
                        <a16:creationId xmlns:a16="http://schemas.microsoft.com/office/drawing/2014/main" id="{AC28504B-96DF-2ADA-F6DC-03C6F92641F4}"/>
                      </a:ext>
                    </a:extLst>
                  </p:cNvPr>
                  <p:cNvGrpSpPr/>
                  <p:nvPr/>
                </p:nvGrpSpPr>
                <p:grpSpPr>
                  <a:xfrm>
                    <a:off x="7825978" y="1024558"/>
                    <a:ext cx="2476504" cy="1861882"/>
                    <a:chOff x="3079432" y="5421407"/>
                    <a:chExt cx="2493626" cy="2063171"/>
                  </a:xfrm>
                </p:grpSpPr>
                <p:pic>
                  <p:nvPicPr>
                    <p:cNvPr id="20" name="Picture 19">
                      <a:extLst>
                        <a:ext uri="{FF2B5EF4-FFF2-40B4-BE49-F238E27FC236}">
                          <a16:creationId xmlns:a16="http://schemas.microsoft.com/office/drawing/2014/main" id="{B72DB3C7-F8A7-FDB8-B3B9-F052AE83A6B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3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4">
                              <a14:imgEffect>
                                <a14:brightnessContrast bright="40000" contrast="-2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15544" r="32968" b="11806"/>
                    <a:stretch/>
                  </p:blipFill>
                  <p:spPr>
                    <a:xfrm>
                      <a:off x="3079432" y="5421407"/>
                      <a:ext cx="2171799" cy="206317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1" name="TextBox 20">
                      <a:extLst>
                        <a:ext uri="{FF2B5EF4-FFF2-40B4-BE49-F238E27FC236}">
                          <a16:creationId xmlns:a16="http://schemas.microsoft.com/office/drawing/2014/main" id="{9EB9EE08-DC7E-10E8-5DF2-5044F79150A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86091" y="5422287"/>
                      <a:ext cx="1286967" cy="2492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020" b="1" dirty="0">
                          <a:solidFill>
                            <a:srgbClr val="FF0000"/>
                          </a:solidFill>
                        </a:rPr>
                        <a:t>Fibroblast </a:t>
                      </a:r>
                      <a:r>
                        <a:rPr lang="en-US" sz="1020" b="1" dirty="0">
                          <a:solidFill>
                            <a:srgbClr val="92D050"/>
                          </a:solidFill>
                        </a:rPr>
                        <a:t>SCLC</a:t>
                      </a:r>
                    </a:p>
                  </p:txBody>
                </p:sp>
              </p:grpSp>
              <p:cxnSp>
                <p:nvCxnSpPr>
                  <p:cNvPr id="19" name="Straight Connector 18">
                    <a:extLst>
                      <a:ext uri="{FF2B5EF4-FFF2-40B4-BE49-F238E27FC236}">
                        <a16:creationId xmlns:a16="http://schemas.microsoft.com/office/drawing/2014/main" id="{2D2220F7-1A2A-8A78-752B-BE52014979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397485" y="2800319"/>
                    <a:ext cx="470136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EBB3D0CD-7379-56D1-4D6C-A5D5B2243D8A}"/>
                  </a:ext>
                </a:extLst>
              </p:cNvPr>
              <p:cNvGrpSpPr/>
              <p:nvPr/>
            </p:nvGrpSpPr>
            <p:grpSpPr>
              <a:xfrm>
                <a:off x="5150802" y="3717554"/>
                <a:ext cx="3133450" cy="2482873"/>
                <a:chOff x="10079107" y="1095575"/>
                <a:chExt cx="3133450" cy="2482873"/>
              </a:xfrm>
            </p:grpSpPr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7577BB23-53A8-0F34-DD94-F423FE8BDEE0}"/>
                    </a:ext>
                  </a:extLst>
                </p:cNvPr>
                <p:cNvSpPr txBox="1"/>
                <p:nvPr/>
              </p:nvSpPr>
              <p:spPr>
                <a:xfrm>
                  <a:off x="10079107" y="2988258"/>
                  <a:ext cx="2225299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CLC tumor phenotype after 7days</a:t>
                  </a:r>
                </a:p>
              </p:txBody>
            </p:sp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ACB6A8E8-49E2-D616-90D3-1F97D0F15BD3}"/>
                    </a:ext>
                  </a:extLst>
                </p:cNvPr>
                <p:cNvGrpSpPr/>
                <p:nvPr/>
              </p:nvGrpSpPr>
              <p:grpSpPr>
                <a:xfrm>
                  <a:off x="10100708" y="1095575"/>
                  <a:ext cx="3111849" cy="2482873"/>
                  <a:chOff x="10206892" y="1068653"/>
                  <a:chExt cx="3111849" cy="2482873"/>
                </a:xfrm>
              </p:grpSpPr>
              <p:pic>
                <p:nvPicPr>
                  <p:cNvPr id="14" name="Picture 13" descr="SC 10 7DAY GFP.jpg">
                    <a:extLst>
                      <a:ext uri="{FF2B5EF4-FFF2-40B4-BE49-F238E27FC236}">
                        <a16:creationId xmlns:a16="http://schemas.microsoft.com/office/drawing/2014/main" id="{8F503372-20DC-68F7-C6E7-FD64E472D75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brightnessContrast bright="4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0206892" y="1068653"/>
                    <a:ext cx="2678868" cy="2482873"/>
                  </a:xfrm>
                  <a:prstGeom prst="rect">
                    <a:avLst/>
                  </a:prstGeom>
                </p:spPr>
              </p:pic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A4EFA86B-20C3-77E8-1936-D48ECA960C2F}"/>
                      </a:ext>
                    </a:extLst>
                  </p:cNvPr>
                  <p:cNvSpPr txBox="1"/>
                  <p:nvPr/>
                </p:nvSpPr>
                <p:spPr>
                  <a:xfrm>
                    <a:off x="11862517" y="1094695"/>
                    <a:ext cx="1456224" cy="2491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20" b="1" dirty="0">
                        <a:solidFill>
                          <a:srgbClr val="FF0000"/>
                        </a:solidFill>
                      </a:rPr>
                      <a:t>Fibroblast </a:t>
                    </a:r>
                    <a:r>
                      <a:rPr lang="en-US" sz="1020" b="1" dirty="0">
                        <a:solidFill>
                          <a:srgbClr val="92D050"/>
                        </a:solidFill>
                      </a:rPr>
                      <a:t>SCLC</a:t>
                    </a:r>
                  </a:p>
                </p:txBody>
              </p:sp>
            </p:grpSp>
          </p:grp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291CB19-DFB7-6317-2779-9769A1490DE7}"/>
                </a:ext>
              </a:extLst>
            </p:cNvPr>
            <p:cNvSpPr txBox="1"/>
            <p:nvPr/>
          </p:nvSpPr>
          <p:spPr>
            <a:xfrm>
              <a:off x="1666240" y="1501653"/>
              <a:ext cx="504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a)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9E5BD14-D455-23E0-BD03-597926E7EF36}"/>
                </a:ext>
              </a:extLst>
            </p:cNvPr>
            <p:cNvSpPr txBox="1"/>
            <p:nvPr/>
          </p:nvSpPr>
          <p:spPr>
            <a:xfrm>
              <a:off x="4276571" y="1501653"/>
              <a:ext cx="504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b)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216C09C-DED2-FFC5-5D68-1859640677D1}"/>
                </a:ext>
              </a:extLst>
            </p:cNvPr>
            <p:cNvSpPr txBox="1"/>
            <p:nvPr/>
          </p:nvSpPr>
          <p:spPr>
            <a:xfrm>
              <a:off x="6777699" y="1491972"/>
              <a:ext cx="504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c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812597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7DC586EA-8256-4352-AAFC-B629EFF0AB02}"/>
              </a:ext>
            </a:extLst>
          </p:cNvPr>
          <p:cNvSpPr txBox="1"/>
          <p:nvPr/>
        </p:nvSpPr>
        <p:spPr>
          <a:xfrm>
            <a:off x="1671450" y="810673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y 1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45726D4-0420-4E4B-9C52-4C0AF11758F8}"/>
              </a:ext>
            </a:extLst>
          </p:cNvPr>
          <p:cNvSpPr txBox="1"/>
          <p:nvPr/>
        </p:nvSpPr>
        <p:spPr>
          <a:xfrm>
            <a:off x="3471091" y="769216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y 3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A5B234D-5C90-4C7A-9BC8-FE7F505F6C94}"/>
              </a:ext>
            </a:extLst>
          </p:cNvPr>
          <p:cNvSpPr txBox="1"/>
          <p:nvPr/>
        </p:nvSpPr>
        <p:spPr>
          <a:xfrm>
            <a:off x="5569292" y="756876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y 7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033F0BC-83C1-4A45-B7C5-557C542BE1D9}"/>
              </a:ext>
            </a:extLst>
          </p:cNvPr>
          <p:cNvSpPr txBox="1"/>
          <p:nvPr/>
        </p:nvSpPr>
        <p:spPr>
          <a:xfrm>
            <a:off x="7404104" y="756876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y 14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3B01754-8391-454F-B449-4B41ED4856C2}"/>
              </a:ext>
            </a:extLst>
          </p:cNvPr>
          <p:cNvSpPr txBox="1"/>
          <p:nvPr/>
        </p:nvSpPr>
        <p:spPr>
          <a:xfrm>
            <a:off x="130866" y="1730671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.5X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BC0C2F4-C173-676C-2AF5-05B615C7B1F6}"/>
              </a:ext>
            </a:extLst>
          </p:cNvPr>
          <p:cNvSpPr txBox="1"/>
          <p:nvPr/>
        </p:nvSpPr>
        <p:spPr>
          <a:xfrm>
            <a:off x="1720021" y="356102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y 1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B4D3363-9E23-C3CF-0CE2-19E34D768DAB}"/>
              </a:ext>
            </a:extLst>
          </p:cNvPr>
          <p:cNvSpPr txBox="1"/>
          <p:nvPr/>
        </p:nvSpPr>
        <p:spPr>
          <a:xfrm>
            <a:off x="3519662" y="351956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y 3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CCF8B4D-95AC-6AD0-C027-1E1005E2BE35}"/>
              </a:ext>
            </a:extLst>
          </p:cNvPr>
          <p:cNvSpPr txBox="1"/>
          <p:nvPr/>
        </p:nvSpPr>
        <p:spPr>
          <a:xfrm>
            <a:off x="5617863" y="350722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y 7 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FF4F4CB-3A97-971B-A53E-08C831F8AFBF}"/>
              </a:ext>
            </a:extLst>
          </p:cNvPr>
          <p:cNvSpPr txBox="1"/>
          <p:nvPr/>
        </p:nvSpPr>
        <p:spPr>
          <a:xfrm>
            <a:off x="7452675" y="350722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y 14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5FAEC33-F055-C271-DF32-10BC4262246D}"/>
              </a:ext>
            </a:extLst>
          </p:cNvPr>
          <p:cNvSpPr txBox="1"/>
          <p:nvPr/>
        </p:nvSpPr>
        <p:spPr>
          <a:xfrm>
            <a:off x="108422" y="4885833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.5X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EC3A9AA-142E-A43A-A5F7-960B582884E5}"/>
              </a:ext>
            </a:extLst>
          </p:cNvPr>
          <p:cNvSpPr txBox="1"/>
          <p:nvPr/>
        </p:nvSpPr>
        <p:spPr>
          <a:xfrm>
            <a:off x="914400" y="170856"/>
            <a:ext cx="834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A9D9EB-0121-5C41-886A-BA2FFCD90801}"/>
              </a:ext>
            </a:extLst>
          </p:cNvPr>
          <p:cNvSpPr txBox="1"/>
          <p:nvPr/>
        </p:nvSpPr>
        <p:spPr>
          <a:xfrm>
            <a:off x="264160" y="1126208"/>
            <a:ext cx="57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9175924-3669-4A87-91C2-D3E98DB5C608}"/>
              </a:ext>
            </a:extLst>
          </p:cNvPr>
          <p:cNvSpPr txBox="1"/>
          <p:nvPr/>
        </p:nvSpPr>
        <p:spPr>
          <a:xfrm>
            <a:off x="183914" y="4021021"/>
            <a:ext cx="57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)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9F09D1F2-AA62-5DB2-199E-1BCBEC536BDE}"/>
              </a:ext>
            </a:extLst>
          </p:cNvPr>
          <p:cNvGrpSpPr/>
          <p:nvPr/>
        </p:nvGrpSpPr>
        <p:grpSpPr>
          <a:xfrm>
            <a:off x="960743" y="1194704"/>
            <a:ext cx="1952958" cy="1466371"/>
            <a:chOff x="960743" y="1194704"/>
            <a:chExt cx="1952958" cy="1466371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1307F996-D2C8-4DDC-A29E-472E3DC3ADA4}"/>
                </a:ext>
              </a:extLst>
            </p:cNvPr>
            <p:cNvGrpSpPr/>
            <p:nvPr/>
          </p:nvGrpSpPr>
          <p:grpSpPr>
            <a:xfrm>
              <a:off x="960743" y="1198035"/>
              <a:ext cx="1952958" cy="1463040"/>
              <a:chOff x="693700" y="662312"/>
              <a:chExt cx="1952958" cy="1463040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D64F480F-4531-4404-85B8-13CF01B490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3700" y="662312"/>
                <a:ext cx="1952958" cy="1463040"/>
              </a:xfrm>
              <a:prstGeom prst="rect">
                <a:avLst/>
              </a:prstGeom>
            </p:spPr>
          </p:pic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EF5C92EC-93B7-40C4-9741-C6511E5BACF6}"/>
                  </a:ext>
                </a:extLst>
              </p:cNvPr>
              <p:cNvCxnSpPr/>
              <p:nvPr/>
            </p:nvCxnSpPr>
            <p:spPr>
              <a:xfrm>
                <a:off x="2376928" y="2064444"/>
                <a:ext cx="225398" cy="0"/>
              </a:xfrm>
              <a:prstGeom prst="line">
                <a:avLst/>
              </a:prstGeom>
              <a:ln w="9525">
                <a:solidFill>
                  <a:schemeClr val="bg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48153A3-CF88-3C57-97F8-4CA42110A46D}"/>
                </a:ext>
              </a:extLst>
            </p:cNvPr>
            <p:cNvSpPr txBox="1"/>
            <p:nvPr/>
          </p:nvSpPr>
          <p:spPr>
            <a:xfrm>
              <a:off x="994370" y="1194704"/>
              <a:ext cx="676328" cy="246221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H 1963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780F1CE3-A3CB-999C-CB72-106A7683FAD1}"/>
              </a:ext>
            </a:extLst>
          </p:cNvPr>
          <p:cNvGrpSpPr/>
          <p:nvPr/>
        </p:nvGrpSpPr>
        <p:grpSpPr>
          <a:xfrm>
            <a:off x="3033623" y="1193100"/>
            <a:ext cx="1952595" cy="1467975"/>
            <a:chOff x="3033623" y="1193100"/>
            <a:chExt cx="1952595" cy="1467975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602511C1-3F6A-4E08-A0A9-54E2E5D4A044}"/>
                </a:ext>
              </a:extLst>
            </p:cNvPr>
            <p:cNvGrpSpPr/>
            <p:nvPr/>
          </p:nvGrpSpPr>
          <p:grpSpPr>
            <a:xfrm>
              <a:off x="3033623" y="1198035"/>
              <a:ext cx="1952595" cy="1463040"/>
              <a:chOff x="2766579" y="662312"/>
              <a:chExt cx="1952595" cy="1463040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37BA8E88-2585-441F-B0DE-DF0A9D541F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66579" y="662312"/>
                <a:ext cx="1952595" cy="1463040"/>
              </a:xfrm>
              <a:prstGeom prst="rect">
                <a:avLst/>
              </a:prstGeom>
            </p:spPr>
          </p:pic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2B77AA51-1FBC-42F5-B04A-62E8F7022FF7}"/>
                  </a:ext>
                </a:extLst>
              </p:cNvPr>
              <p:cNvCxnSpPr/>
              <p:nvPr/>
            </p:nvCxnSpPr>
            <p:spPr>
              <a:xfrm>
                <a:off x="4346602" y="2064444"/>
                <a:ext cx="225398" cy="0"/>
              </a:xfrm>
              <a:prstGeom prst="line">
                <a:avLst/>
              </a:prstGeom>
              <a:ln w="9525">
                <a:solidFill>
                  <a:schemeClr val="bg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1B5C3F0-1AB8-C858-C911-936F3DB798A1}"/>
                </a:ext>
              </a:extLst>
            </p:cNvPr>
            <p:cNvSpPr txBox="1"/>
            <p:nvPr/>
          </p:nvSpPr>
          <p:spPr>
            <a:xfrm>
              <a:off x="3042630" y="1193100"/>
              <a:ext cx="700948" cy="246221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H 1963</a:t>
              </a: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D21D7961-9539-E874-DB90-92FD64ADBA87}"/>
              </a:ext>
            </a:extLst>
          </p:cNvPr>
          <p:cNvGrpSpPr/>
          <p:nvPr/>
        </p:nvGrpSpPr>
        <p:grpSpPr>
          <a:xfrm>
            <a:off x="5119363" y="1198035"/>
            <a:ext cx="1953116" cy="1463040"/>
            <a:chOff x="5119363" y="1198035"/>
            <a:chExt cx="1953116" cy="146304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010DBFC-55B5-4CD7-8F01-7FF9A0DA31E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19521" y="1198035"/>
              <a:ext cx="1952958" cy="146304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B80EBDA-4B1E-52E2-0CBD-8007848966C3}"/>
                </a:ext>
              </a:extLst>
            </p:cNvPr>
            <p:cNvSpPr txBox="1"/>
            <p:nvPr/>
          </p:nvSpPr>
          <p:spPr>
            <a:xfrm>
              <a:off x="5119363" y="1223994"/>
              <a:ext cx="671837" cy="246221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H 1963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DFB0E1C4-1715-D444-8279-AB4F1B4A6D31}"/>
              </a:ext>
            </a:extLst>
          </p:cNvPr>
          <p:cNvGrpSpPr/>
          <p:nvPr/>
        </p:nvGrpSpPr>
        <p:grpSpPr>
          <a:xfrm>
            <a:off x="7160526" y="1175822"/>
            <a:ext cx="1980459" cy="1463040"/>
            <a:chOff x="7160526" y="1175822"/>
            <a:chExt cx="1980459" cy="1463040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5D22606-7CD0-45B8-9EF9-975E0689152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88027" y="1175822"/>
              <a:ext cx="1952958" cy="1463040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30652DA-BD68-C362-B3AD-E5BF6B2EC4D4}"/>
                </a:ext>
              </a:extLst>
            </p:cNvPr>
            <p:cNvSpPr txBox="1"/>
            <p:nvPr/>
          </p:nvSpPr>
          <p:spPr>
            <a:xfrm>
              <a:off x="7160526" y="1194704"/>
              <a:ext cx="700948" cy="244617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H 1963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5972B71F-AE13-5306-D871-F3C2E1222AD2}"/>
              </a:ext>
            </a:extLst>
          </p:cNvPr>
          <p:cNvGrpSpPr/>
          <p:nvPr/>
        </p:nvGrpSpPr>
        <p:grpSpPr>
          <a:xfrm>
            <a:off x="979790" y="4057412"/>
            <a:ext cx="1914864" cy="1567553"/>
            <a:chOff x="979790" y="4057412"/>
            <a:chExt cx="1914864" cy="1567553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0E7AECD4-0B02-F3BC-51F8-E50CBF8AFF75}"/>
                </a:ext>
              </a:extLst>
            </p:cNvPr>
            <p:cNvGrpSpPr/>
            <p:nvPr/>
          </p:nvGrpSpPr>
          <p:grpSpPr>
            <a:xfrm>
              <a:off x="979790" y="4057412"/>
              <a:ext cx="1914864" cy="1567553"/>
              <a:chOff x="971107" y="879989"/>
              <a:chExt cx="1828800" cy="1567553"/>
            </a:xfrm>
          </p:grpSpPr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B5712C80-5117-B8D5-3CDB-3785061790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971107" y="879989"/>
                <a:ext cx="1828800" cy="1567553"/>
              </a:xfrm>
              <a:prstGeom prst="rect">
                <a:avLst/>
              </a:prstGeom>
            </p:spPr>
          </p:pic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6D59D335-2986-B6D0-C5F6-DB535F3D6102}"/>
                  </a:ext>
                </a:extLst>
              </p:cNvPr>
              <p:cNvCxnSpPr/>
              <p:nvPr/>
            </p:nvCxnSpPr>
            <p:spPr>
              <a:xfrm>
                <a:off x="2460700" y="2322818"/>
                <a:ext cx="248934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606C141-8A68-7891-2272-93EE82DB30B6}"/>
                </a:ext>
              </a:extLst>
            </p:cNvPr>
            <p:cNvSpPr txBox="1"/>
            <p:nvPr/>
          </p:nvSpPr>
          <p:spPr>
            <a:xfrm>
              <a:off x="1000746" y="4074811"/>
              <a:ext cx="671837" cy="246221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H 82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24B4DB7B-7CFE-86A7-6923-7ABE2AD25AD1}"/>
              </a:ext>
            </a:extLst>
          </p:cNvPr>
          <p:cNvGrpSpPr/>
          <p:nvPr/>
        </p:nvGrpSpPr>
        <p:grpSpPr>
          <a:xfrm>
            <a:off x="3063299" y="4048146"/>
            <a:ext cx="1942723" cy="1576820"/>
            <a:chOff x="3063299" y="4048146"/>
            <a:chExt cx="1942723" cy="1576820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3B8C6BA2-AFA4-7DAB-FF30-5BFAC9A3D134}"/>
                </a:ext>
              </a:extLst>
            </p:cNvPr>
            <p:cNvGrpSpPr/>
            <p:nvPr/>
          </p:nvGrpSpPr>
          <p:grpSpPr>
            <a:xfrm>
              <a:off x="3063299" y="4057413"/>
              <a:ext cx="1942723" cy="1567553"/>
              <a:chOff x="2916268" y="879989"/>
              <a:chExt cx="1828800" cy="1567553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0A32587C-6DE7-33F4-9B04-B0DCC0D257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16268" y="879989"/>
                <a:ext cx="1828800" cy="1567553"/>
              </a:xfrm>
              <a:prstGeom prst="rect">
                <a:avLst/>
              </a:prstGeom>
            </p:spPr>
          </p:pic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C4B38EEC-C243-0AE2-0B08-E35821752D20}"/>
                  </a:ext>
                </a:extLst>
              </p:cNvPr>
              <p:cNvCxnSpPr/>
              <p:nvPr/>
            </p:nvCxnSpPr>
            <p:spPr>
              <a:xfrm>
                <a:off x="4458624" y="2376505"/>
                <a:ext cx="248934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D929E32-141D-D8BD-1F90-EA0D133E09FD}"/>
                </a:ext>
              </a:extLst>
            </p:cNvPr>
            <p:cNvSpPr txBox="1"/>
            <p:nvPr/>
          </p:nvSpPr>
          <p:spPr>
            <a:xfrm>
              <a:off x="3073815" y="4048146"/>
              <a:ext cx="671837" cy="246221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H 82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D04C3DDF-F43B-6974-9BB9-8A5585894303}"/>
              </a:ext>
            </a:extLst>
          </p:cNvPr>
          <p:cNvGrpSpPr/>
          <p:nvPr/>
        </p:nvGrpSpPr>
        <p:grpSpPr>
          <a:xfrm>
            <a:off x="5115450" y="4021021"/>
            <a:ext cx="1963147" cy="1603945"/>
            <a:chOff x="5115450" y="4021021"/>
            <a:chExt cx="1963147" cy="1603945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AFAD84CA-AE47-DA2A-87F0-1A5EA7096AD9}"/>
                </a:ext>
              </a:extLst>
            </p:cNvPr>
            <p:cNvGrpSpPr/>
            <p:nvPr/>
          </p:nvGrpSpPr>
          <p:grpSpPr>
            <a:xfrm>
              <a:off x="5115450" y="4057413"/>
              <a:ext cx="1963147" cy="1567553"/>
              <a:chOff x="4893419" y="879990"/>
              <a:chExt cx="1828800" cy="1567553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54EBE556-D775-6A52-10EB-FFAA37C597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93419" y="879990"/>
                <a:ext cx="1828800" cy="1567553"/>
              </a:xfrm>
              <a:prstGeom prst="rect">
                <a:avLst/>
              </a:prstGeom>
            </p:spPr>
          </p:pic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48F882D0-BDEB-B271-9841-6D5C9D4E9FF6}"/>
                  </a:ext>
                </a:extLst>
              </p:cNvPr>
              <p:cNvCxnSpPr/>
              <p:nvPr/>
            </p:nvCxnSpPr>
            <p:spPr>
              <a:xfrm>
                <a:off x="6343701" y="2240536"/>
                <a:ext cx="248934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5FE97A0-8FF3-E26F-C5A8-0447F37F27B1}"/>
                </a:ext>
              </a:extLst>
            </p:cNvPr>
            <p:cNvSpPr txBox="1"/>
            <p:nvPr/>
          </p:nvSpPr>
          <p:spPr>
            <a:xfrm>
              <a:off x="5119363" y="4021021"/>
              <a:ext cx="671837" cy="246221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H 82</a:t>
              </a: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ACCC4AFD-B065-5339-B8BF-7E9DBC1299E9}"/>
              </a:ext>
            </a:extLst>
          </p:cNvPr>
          <p:cNvGrpSpPr/>
          <p:nvPr/>
        </p:nvGrpSpPr>
        <p:grpSpPr>
          <a:xfrm>
            <a:off x="7188025" y="4032733"/>
            <a:ext cx="1952958" cy="1567553"/>
            <a:chOff x="7188025" y="4032733"/>
            <a:chExt cx="1952958" cy="1567553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C6D0A957-278B-0EC8-7D66-F88705265241}"/>
                </a:ext>
              </a:extLst>
            </p:cNvPr>
            <p:cNvGrpSpPr/>
            <p:nvPr/>
          </p:nvGrpSpPr>
          <p:grpSpPr>
            <a:xfrm>
              <a:off x="7188025" y="4032733"/>
              <a:ext cx="1952958" cy="1567553"/>
              <a:chOff x="6981720" y="1022550"/>
              <a:chExt cx="1590783" cy="1567553"/>
            </a:xfrm>
          </p:grpSpPr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05479244-753F-7AE7-77AA-748E6E26A8A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049" t="2896"/>
              <a:stretch/>
            </p:blipFill>
            <p:spPr>
              <a:xfrm>
                <a:off x="6981720" y="1022550"/>
                <a:ext cx="1590783" cy="1567553"/>
              </a:xfrm>
              <a:prstGeom prst="rect">
                <a:avLst/>
              </a:prstGeom>
            </p:spPr>
          </p:pic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84DB12ED-B340-A847-20D3-6E50DC3D470C}"/>
                  </a:ext>
                </a:extLst>
              </p:cNvPr>
              <p:cNvCxnSpPr/>
              <p:nvPr/>
            </p:nvCxnSpPr>
            <p:spPr>
              <a:xfrm>
                <a:off x="8234435" y="2319207"/>
                <a:ext cx="248934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51184F1-E361-5D15-5FCB-38340AA12F57}"/>
                </a:ext>
              </a:extLst>
            </p:cNvPr>
            <p:cNvSpPr txBox="1"/>
            <p:nvPr/>
          </p:nvSpPr>
          <p:spPr>
            <a:xfrm>
              <a:off x="7189637" y="4048146"/>
              <a:ext cx="671837" cy="246221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H 8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825219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AF1ABBB-64C7-5A2C-66E7-D835E2BFACDC}"/>
              </a:ext>
            </a:extLst>
          </p:cNvPr>
          <p:cNvSpPr txBox="1"/>
          <p:nvPr/>
        </p:nvSpPr>
        <p:spPr>
          <a:xfrm>
            <a:off x="4236720" y="627561"/>
            <a:ext cx="256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0B7E87C-B20E-FD22-D527-760FDFDCB349}"/>
              </a:ext>
            </a:extLst>
          </p:cNvPr>
          <p:cNvGrpSpPr/>
          <p:nvPr/>
        </p:nvGrpSpPr>
        <p:grpSpPr>
          <a:xfrm>
            <a:off x="2716575" y="1389561"/>
            <a:ext cx="5796072" cy="4078877"/>
            <a:chOff x="1111295" y="1438003"/>
            <a:chExt cx="5796072" cy="407887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1A24BF6-7827-9A71-EFE5-4164654340F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11295" y="1438003"/>
              <a:ext cx="5796072" cy="407887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5152E79-D685-6435-48BE-14A71917817E}"/>
                </a:ext>
              </a:extLst>
            </p:cNvPr>
            <p:cNvSpPr txBox="1"/>
            <p:nvPr/>
          </p:nvSpPr>
          <p:spPr>
            <a:xfrm>
              <a:off x="3911600" y="4754880"/>
              <a:ext cx="14224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[Conc.]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763179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F10F056C-DE64-A788-2EED-5A6106494A3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467" y="1970447"/>
            <a:ext cx="10905066" cy="291710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59FB4D0-7839-5AE3-C1EA-727552E8D432}"/>
              </a:ext>
            </a:extLst>
          </p:cNvPr>
          <p:cNvSpPr txBox="1"/>
          <p:nvPr/>
        </p:nvSpPr>
        <p:spPr>
          <a:xfrm>
            <a:off x="4815840" y="1308776"/>
            <a:ext cx="256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</a:p>
        </p:txBody>
      </p:sp>
    </p:spTree>
    <p:extLst>
      <p:ext uri="{BB962C8B-B14F-4D97-AF65-F5344CB8AC3E}">
        <p14:creationId xmlns:p14="http://schemas.microsoft.com/office/powerpoint/2010/main" val="16909458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44F6577-FC81-42DC-E23E-F24E38EA6E81}"/>
              </a:ext>
            </a:extLst>
          </p:cNvPr>
          <p:cNvSpPr txBox="1"/>
          <p:nvPr/>
        </p:nvSpPr>
        <p:spPr>
          <a:xfrm>
            <a:off x="1933574" y="638216"/>
            <a:ext cx="894524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dirty="0">
                <a:solidFill>
                  <a:srgbClr val="000000"/>
                </a:solidFill>
                <a:effectLst/>
                <a:latin typeface="TimesNewRomanPS-BoldMT"/>
              </a:rPr>
              <a:t>Supplementary Table 1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omparison of IC50 values of different SCLC cell lines</a:t>
            </a:r>
            <a:r>
              <a:rPr lang="en-US" dirty="0"/>
              <a:t> </a:t>
            </a:r>
            <a:br>
              <a:rPr lang="en-US" dirty="0"/>
            </a:br>
            <a:endParaRPr lang="en-US" dirty="0"/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BA73F8E-71F5-AE65-02E1-C9BCCE6C1A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3481603"/>
              </p:ext>
            </p:extLst>
          </p:nvPr>
        </p:nvGraphicFramePr>
        <p:xfrm>
          <a:off x="1933574" y="1559114"/>
          <a:ext cx="8785227" cy="3632644"/>
        </p:xfrm>
        <a:graphic>
          <a:graphicData uri="http://schemas.openxmlformats.org/drawingml/2006/table">
            <a:tbl>
              <a:tblPr firstRow="1" bandRow="1"/>
              <a:tblGrid>
                <a:gridCol w="1978131">
                  <a:extLst>
                    <a:ext uri="{9D8B030D-6E8A-4147-A177-3AD203B41FA5}">
                      <a16:colId xmlns:a16="http://schemas.microsoft.com/office/drawing/2014/main" val="3672231842"/>
                    </a:ext>
                  </a:extLst>
                </a:gridCol>
                <a:gridCol w="2408664">
                  <a:extLst>
                    <a:ext uri="{9D8B030D-6E8A-4147-A177-3AD203B41FA5}">
                      <a16:colId xmlns:a16="http://schemas.microsoft.com/office/drawing/2014/main" val="14728917"/>
                    </a:ext>
                  </a:extLst>
                </a:gridCol>
                <a:gridCol w="2199216">
                  <a:extLst>
                    <a:ext uri="{9D8B030D-6E8A-4147-A177-3AD203B41FA5}">
                      <a16:colId xmlns:a16="http://schemas.microsoft.com/office/drawing/2014/main" val="2232312659"/>
                    </a:ext>
                  </a:extLst>
                </a:gridCol>
                <a:gridCol w="2199216">
                  <a:extLst>
                    <a:ext uri="{9D8B030D-6E8A-4147-A177-3AD203B41FA5}">
                      <a16:colId xmlns:a16="http://schemas.microsoft.com/office/drawing/2014/main" val="2008246408"/>
                    </a:ext>
                  </a:extLst>
                </a:gridCol>
              </a:tblGrid>
              <a:tr h="90816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US" sz="2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isplatin (µM)</a:t>
                      </a:r>
                      <a:endParaRPr lang="en-U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toposide (µM)</a:t>
                      </a:r>
                      <a:endParaRPr lang="en-U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mbined (µM)</a:t>
                      </a:r>
                      <a:endParaRPr lang="en-U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0473718"/>
                  </a:ext>
                </a:extLst>
              </a:tr>
              <a:tr h="908161">
                <a:tc>
                  <a:txBody>
                    <a:bodyPr/>
                    <a:lstStyle/>
                    <a:p>
                      <a:pPr marL="0" marR="0" indent="45720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1963</a:t>
                      </a:r>
                      <a:endParaRPr lang="en-U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.32±1.34</a:t>
                      </a:r>
                      <a:endParaRPr lang="en-U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.85±1.52</a:t>
                      </a:r>
                      <a:endParaRPr lang="en-U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11±0.47</a:t>
                      </a:r>
                      <a:endParaRPr lang="en-U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0112670"/>
                  </a:ext>
                </a:extLst>
              </a:tr>
              <a:tr h="908161">
                <a:tc>
                  <a:txBody>
                    <a:bodyPr/>
                    <a:lstStyle/>
                    <a:p>
                      <a:pPr marL="0" marR="0" indent="45720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526</a:t>
                      </a:r>
                      <a:endParaRPr lang="en-U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97±1.26</a:t>
                      </a:r>
                      <a:endParaRPr lang="en-U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1±0.83</a:t>
                      </a:r>
                      <a:endParaRPr lang="en-U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68±0.44</a:t>
                      </a: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9501666"/>
                  </a:ext>
                </a:extLst>
              </a:tr>
              <a:tr h="908161">
                <a:tc>
                  <a:txBody>
                    <a:bodyPr/>
                    <a:lstStyle/>
                    <a:p>
                      <a:pPr marL="0" marR="0" indent="45720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82</a:t>
                      </a: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11</a:t>
                      </a: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1.52</a:t>
                      </a:r>
                      <a:endParaRPr lang="en-U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57</a:t>
                      </a: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0.43</a:t>
                      </a:r>
                      <a:endParaRPr lang="en-U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87</a:t>
                      </a:r>
                      <a:r>
                        <a:rPr lang="en-US" sz="2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1.02</a:t>
                      </a:r>
                      <a:endParaRPr lang="en-U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01855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67590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4</TotalTime>
  <Words>287</Words>
  <Application>Microsoft Macintosh PowerPoint</Application>
  <PresentationFormat>Widescreen</PresentationFormat>
  <Paragraphs>58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TimesNewRomanPS-BoldMT</vt:lpstr>
      <vt:lpstr>Office Theme</vt:lpstr>
      <vt:lpstr>PowerPoint Presentation</vt:lpstr>
      <vt:lpstr>Supplementary Figures legends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dani Sen</dc:creator>
  <cp:lastModifiedBy>Gomperts, Brigitte N.</cp:lastModifiedBy>
  <cp:revision>17</cp:revision>
  <dcterms:created xsi:type="dcterms:W3CDTF">2023-04-21T19:42:00Z</dcterms:created>
  <dcterms:modified xsi:type="dcterms:W3CDTF">2023-06-15T05:28:59Z</dcterms:modified>
</cp:coreProperties>
</file>